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2" d="100"/>
          <a:sy n="72" d="100"/>
        </p:scale>
        <p:origin x="81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147B66-AF2C-44A3-9E90-27CACC9621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D4B240B-EACA-4DC8-9BA5-14F4C6BA158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24F9019-D07D-445E-87F7-DC8C2B3884B4}"/>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263904C8-29E2-4B54-8023-0CC33B9D9D4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166C25-28FA-4309-875C-EFC06F6365A3}"/>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37053505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E8D159-BF4E-4BFC-8EE9-316F3DB3014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8AB8038-A955-4689-B985-E08568568E1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DAF9FE-8431-4B97-B757-543AF43FE152}"/>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D7ED5808-7013-4419-ABE4-6E8B4988E33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75329E-D912-446E-8872-0C58EA678519}"/>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9926532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187C278-C7D6-4514-B967-18FC7923401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DF4A6E5-7197-4C63-88DF-0E87970DE7F8}"/>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0EE592-7A9F-4B34-81EB-90F38E837614}"/>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FCA6049F-BCE1-4D81-9EF4-0B72DF3D2E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DFBB77-D179-4346-A0A1-E2F748C49F43}"/>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3813589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B0766A-DB92-4D07-ACDB-B84C09B3E81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06B36CE-5534-408C-93D6-40CBCCBA520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0E69A9-E530-4C68-86A6-E46088914343}"/>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B4BEABFD-E54C-40CE-8208-028CA4F8A1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28DA45-7837-4B05-9B4E-976EBCDF1491}"/>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16466697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1A60DE-48AB-4C06-AB09-3FE921BD131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72BDA00-264C-4A10-B3FB-372FE28C99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C8EDD50-3442-4310-BDC1-190E1ACCEC31}"/>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CDAFA96F-B1E2-4375-AD5D-F60668100F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A9F37D-FE72-4CF6-99E3-4B70AB0426EB}"/>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27938985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E7278C-6AA4-4E82-A8E8-C46F139D5C8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D616F3-E332-49E6-8FD2-7D732CBB34A3}"/>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7783CDC-59C8-44F0-AD5F-B2B753B01A61}"/>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96479CE-C447-4073-811B-4DB39EE56164}"/>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6" name="Footer Placeholder 5">
            <a:extLst>
              <a:ext uri="{FF2B5EF4-FFF2-40B4-BE49-F238E27FC236}">
                <a16:creationId xmlns:a16="http://schemas.microsoft.com/office/drawing/2014/main" id="{5A0E880D-CE23-48CB-B9B0-F9FE3FB608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AE4EBC-5129-42AA-A9FE-F4BA305E8232}"/>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41467834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C0DF8-955E-4EBB-9346-EC17460EF6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8C7727D-2438-49F4-B866-3F422F732F6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C2468D6-1A36-4F67-93A7-178DD7601B55}"/>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4A5B1BA-291E-4097-ADEC-FA8BD8D40B7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815C7024-0E3E-4ED0-A20B-BB6D46899FE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2DC995A-5829-418B-B597-EACF5EDB550A}"/>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8" name="Footer Placeholder 7">
            <a:extLst>
              <a:ext uri="{FF2B5EF4-FFF2-40B4-BE49-F238E27FC236}">
                <a16:creationId xmlns:a16="http://schemas.microsoft.com/office/drawing/2014/main" id="{4241C6CE-236A-4ECA-9C5F-D3BF7E0B71F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BB47558-F46B-43A4-9E2B-CD061CD669B8}"/>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671853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60C343-06C6-463A-B42A-48C4FF26F07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A135227-B24C-479D-8B4C-91C2716307C1}"/>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4" name="Footer Placeholder 3">
            <a:extLst>
              <a:ext uri="{FF2B5EF4-FFF2-40B4-BE49-F238E27FC236}">
                <a16:creationId xmlns:a16="http://schemas.microsoft.com/office/drawing/2014/main" id="{AC824B48-E928-4AB3-A8C5-3819446B5D1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815C82B-4593-4B4A-B26F-2CFD396B7C07}"/>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19483836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3B8C8A1-294C-4312-B857-E577410BAA83}"/>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3" name="Footer Placeholder 2">
            <a:extLst>
              <a:ext uri="{FF2B5EF4-FFF2-40B4-BE49-F238E27FC236}">
                <a16:creationId xmlns:a16="http://schemas.microsoft.com/office/drawing/2014/main" id="{85C8B5A2-9237-4087-BA23-7F1A8F8158E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F37EC79-14F7-4DD1-BFA2-E32764618944}"/>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20915401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D2A8F3-9EE2-4E84-B850-2B3780749D8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966B85E-9CFF-4789-803B-C918B923C98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A9AECFD-57FA-471F-98A5-BD5C85B07E6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608EC939-A5D8-4825-9B4A-FB56EB7B2C06}"/>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6" name="Footer Placeholder 5">
            <a:extLst>
              <a:ext uri="{FF2B5EF4-FFF2-40B4-BE49-F238E27FC236}">
                <a16:creationId xmlns:a16="http://schemas.microsoft.com/office/drawing/2014/main" id="{0CDE4DE0-33F9-4585-98EC-A0AD849FB3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771212E-9FD2-4E29-B420-43738BC1FFB8}"/>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29422952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7F7E15-AAAA-4B1D-A012-BF8766F856D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5052719-E1BE-4907-8833-D04F9F7031E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2913751-2797-4355-9FD4-2BFEA607C3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B6442D7-A9B6-45B8-96F4-882CB8B0F711}"/>
              </a:ext>
            </a:extLst>
          </p:cNvPr>
          <p:cNvSpPr>
            <a:spLocks noGrp="1"/>
          </p:cNvSpPr>
          <p:nvPr>
            <p:ph type="dt" sz="half" idx="10"/>
          </p:nvPr>
        </p:nvSpPr>
        <p:spPr/>
        <p:txBody>
          <a:bodyPr/>
          <a:lstStyle/>
          <a:p>
            <a:fld id="{4433BD5B-BAF9-440D-98D2-AACDF33A5D64}" type="datetimeFigureOut">
              <a:rPr lang="en-US" smtClean="0"/>
              <a:t>10/21/2022</a:t>
            </a:fld>
            <a:endParaRPr lang="en-US"/>
          </a:p>
        </p:txBody>
      </p:sp>
      <p:sp>
        <p:nvSpPr>
          <p:cNvPr id="6" name="Footer Placeholder 5">
            <a:extLst>
              <a:ext uri="{FF2B5EF4-FFF2-40B4-BE49-F238E27FC236}">
                <a16:creationId xmlns:a16="http://schemas.microsoft.com/office/drawing/2014/main" id="{F68354A7-C046-4CB0-9CC6-02824D76DBA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A870F5-EA92-4775-A8FE-0F844EEF1099}"/>
              </a:ext>
            </a:extLst>
          </p:cNvPr>
          <p:cNvSpPr>
            <a:spLocks noGrp="1"/>
          </p:cNvSpPr>
          <p:nvPr>
            <p:ph type="sldNum" sz="quarter" idx="12"/>
          </p:nvPr>
        </p:nvSpPr>
        <p:spPr/>
        <p:txBody>
          <a:bodyPr/>
          <a:lstStyle/>
          <a:p>
            <a:fld id="{2D28C7B3-4470-434E-B90E-7A393A71A8CC}" type="slidenum">
              <a:rPr lang="en-US" smtClean="0"/>
              <a:t>‹#›</a:t>
            </a:fld>
            <a:endParaRPr lang="en-US"/>
          </a:p>
        </p:txBody>
      </p:sp>
    </p:spTree>
    <p:extLst>
      <p:ext uri="{BB962C8B-B14F-4D97-AF65-F5344CB8AC3E}">
        <p14:creationId xmlns:p14="http://schemas.microsoft.com/office/powerpoint/2010/main" val="11382626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E9DBB19-1FBB-4E22-88EA-ECFCF966A04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A7C02D5-A669-42DA-9412-0AA8F4F72B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22C406-7D94-4EAE-B7EF-8553A8B1345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33BD5B-BAF9-440D-98D2-AACDF33A5D64}" type="datetimeFigureOut">
              <a:rPr lang="en-US" smtClean="0"/>
              <a:t>10/21/2022</a:t>
            </a:fld>
            <a:endParaRPr lang="en-US"/>
          </a:p>
        </p:txBody>
      </p:sp>
      <p:sp>
        <p:nvSpPr>
          <p:cNvPr id="5" name="Footer Placeholder 4">
            <a:extLst>
              <a:ext uri="{FF2B5EF4-FFF2-40B4-BE49-F238E27FC236}">
                <a16:creationId xmlns:a16="http://schemas.microsoft.com/office/drawing/2014/main" id="{6FD6532D-C7E7-4C82-99FC-F47C4F5731F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2AEEB56-3511-4066-A64F-22CE7D7C743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D28C7B3-4470-434E-B90E-7A393A71A8CC}" type="slidenum">
              <a:rPr lang="en-US" smtClean="0"/>
              <a:t>‹#›</a:t>
            </a:fld>
            <a:endParaRPr lang="en-US"/>
          </a:p>
        </p:txBody>
      </p:sp>
    </p:spTree>
    <p:extLst>
      <p:ext uri="{BB962C8B-B14F-4D97-AF65-F5344CB8AC3E}">
        <p14:creationId xmlns:p14="http://schemas.microsoft.com/office/powerpoint/2010/main" val="6336926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ED78C3CB-6DDF-44DB-B86F-67A21564671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3515" y="0"/>
            <a:ext cx="9797143" cy="6858000"/>
          </a:xfrm>
          <a:prstGeom prst="rect">
            <a:avLst/>
          </a:prstGeom>
        </p:spPr>
      </p:pic>
      <p:sp>
        <p:nvSpPr>
          <p:cNvPr id="6" name="Rectangle 5">
            <a:extLst>
              <a:ext uri="{FF2B5EF4-FFF2-40B4-BE49-F238E27FC236}">
                <a16:creationId xmlns:a16="http://schemas.microsoft.com/office/drawing/2014/main" id="{C1C5FD40-A0C0-4B30-A264-1CA0EE41E5EF}"/>
              </a:ext>
            </a:extLst>
          </p:cNvPr>
          <p:cNvSpPr/>
          <p:nvPr/>
        </p:nvSpPr>
        <p:spPr>
          <a:xfrm>
            <a:off x="7911548" y="4919008"/>
            <a:ext cx="4280452" cy="1938992"/>
          </a:xfrm>
          <a:prstGeom prst="rect">
            <a:avLst/>
          </a:prstGeom>
        </p:spPr>
        <p:txBody>
          <a:bodyPr wrap="square">
            <a:spAutoFit/>
          </a:bodyPr>
          <a:lstStyle/>
          <a:p>
            <a:pPr algn="just">
              <a:spcAft>
                <a:spcPts val="1000"/>
              </a:spcAft>
            </a:pPr>
            <a:r>
              <a:rPr lang="en-US" sz="1200" b="1" i="1" dirty="0">
                <a:solidFill>
                  <a:srgbClr val="1F497D"/>
                </a:solidFill>
                <a:latin typeface="Cambria" panose="02040503050406030204" pitchFamily="18" charset="0"/>
                <a:ea typeface="Calibri" panose="020F0502020204030204" pitchFamily="34" charset="0"/>
                <a:cs typeface="Times New Roman" panose="02020603050405020304" pitchFamily="18" charset="0"/>
              </a:rPr>
              <a:t>Figure S16:</a:t>
            </a:r>
            <a:r>
              <a:rPr lang="en-US" sz="1200" b="1" dirty="0">
                <a:solidFill>
                  <a:srgbClr val="1F497D"/>
                </a:solidFill>
                <a:latin typeface="Cambria" panose="02040503050406030204" pitchFamily="18" charset="0"/>
                <a:ea typeface="Calibri" panose="020F0502020204030204" pitchFamily="34" charset="0"/>
                <a:cs typeface="Times New Roman" panose="02020603050405020304" pitchFamily="18" charset="0"/>
              </a:rPr>
              <a:t> Species-wise MDS representation of putative R proteins from the Fabaceae family. </a:t>
            </a:r>
            <a:r>
              <a:rPr lang="en-US" sz="1200" dirty="0">
                <a:solidFill>
                  <a:srgbClr val="1F497D"/>
                </a:solidFill>
                <a:latin typeface="Cambria" panose="02040503050406030204" pitchFamily="18" charset="0"/>
                <a:ea typeface="Calibri" panose="020F0502020204030204" pitchFamily="34" charset="0"/>
                <a:cs typeface="Times New Roman" panose="02020603050405020304" pitchFamily="18" charset="0"/>
              </a:rPr>
              <a:t>The putative R proteins from each of the nine representative species were separated into seven groups including L, N, NL, CN, TN, CNL, and TNL. Their multiple alignments were obtained using MUSCLE and their corresponding distance matrices were plotted in a low dimensional space by metric multidimensional scaling (MDS). Each class is represented with a separate color; N in dark green, L in red, NL in light blue, CN in dark golden, TN in dark orchid, CNL in orange, and TNL in coral.      </a:t>
            </a:r>
            <a:r>
              <a:rPr lang="en-US" sz="1200" b="1" dirty="0">
                <a:solidFill>
                  <a:srgbClr val="1F497D"/>
                </a:solidFill>
                <a:latin typeface="Cambria" panose="02040503050406030204" pitchFamily="18" charset="0"/>
                <a:ea typeface="Calibri" panose="020F0502020204030204" pitchFamily="34" charset="0"/>
                <a:cs typeface="Times New Roman" panose="02020603050405020304" pitchFamily="18" charset="0"/>
              </a:rPr>
              <a:t> </a:t>
            </a:r>
            <a:endParaRPr lang="en-US" sz="1200" i="1" dirty="0">
              <a:solidFill>
                <a:srgbClr val="1F497D"/>
              </a:solidFill>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482525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5</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Cambria</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shal Singh Negi</dc:creator>
  <cp:lastModifiedBy>Vishal Singh Negi</cp:lastModifiedBy>
  <cp:revision>1</cp:revision>
  <dcterms:created xsi:type="dcterms:W3CDTF">2022-10-21T18:33:19Z</dcterms:created>
  <dcterms:modified xsi:type="dcterms:W3CDTF">2022-10-21T18:34:18Z</dcterms:modified>
</cp:coreProperties>
</file>